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6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97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1526" y="-2256"/>
      </p:cViewPr>
      <p:guideLst>
        <p:guide orient="horz" pos="307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052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139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374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9591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2171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227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86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802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8859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9317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5298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FA938-E9C1-41F4-9EE3-44DED8550B40}" type="datetimeFigureOut">
              <a:rPr kumimoji="1" lang="ja-JP" altLang="en-US" smtClean="0"/>
              <a:t>2021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5960A-D29E-4848-A4FF-32E427DCF3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799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">
            <a:extLst>
              <a:ext uri="{FF2B5EF4-FFF2-40B4-BE49-F238E27FC236}">
                <a16:creationId xmlns:a16="http://schemas.microsoft.com/office/drawing/2014/main" id="{CE0B37A6-FFB3-4C7D-A514-3BE9C0A8D3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579" y="1284284"/>
            <a:ext cx="6184841" cy="442418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59229F2-07B5-4BA7-9199-0B75EDA491A5}"/>
              </a:ext>
            </a:extLst>
          </p:cNvPr>
          <p:cNvSpPr txBox="1"/>
          <p:nvPr/>
        </p:nvSpPr>
        <p:spPr>
          <a:xfrm>
            <a:off x="689723" y="6633403"/>
            <a:ext cx="583044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en-US" sz="12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Differentially abundant membrane proteins under control</a:t>
            </a:r>
          </a:p>
          <a:p>
            <a:r>
              <a:rPr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and plant-derived smoke solution treatment. Each group was performed with </a:t>
            </a:r>
          </a:p>
          <a:p>
            <a:r>
              <a:rPr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3 biological replicates. </a:t>
            </a:r>
            <a:r>
              <a:rPr kumimoji="1"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red colors mean  untreated and treated proteins,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spectively, with plant-derived smoke solution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200" b="0" i="0" dirty="0">
              <a:solidFill>
                <a:srgbClr val="222222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94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">
            <a:extLst>
              <a:ext uri="{FF2B5EF4-FFF2-40B4-BE49-F238E27FC236}">
                <a16:creationId xmlns:a16="http://schemas.microsoft.com/office/drawing/2014/main" id="{AE38EE8B-1C3E-44F8-95D4-6B288DD2B7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8658" y="1011793"/>
            <a:ext cx="5518448" cy="5193366"/>
          </a:xfrm>
          <a:prstGeom prst="rect">
            <a:avLst/>
          </a:prstGeom>
        </p:spPr>
      </p:pic>
      <p:pic>
        <p:nvPicPr>
          <p:cNvPr id="6" name="Picture 1">
            <a:extLst>
              <a:ext uri="{FF2B5EF4-FFF2-40B4-BE49-F238E27FC236}">
                <a16:creationId xmlns:a16="http://schemas.microsoft.com/office/drawing/2014/main" id="{32E85FAD-1881-4A47-999D-0E8A45A4C06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96236" r="19850" b="378"/>
          <a:stretch/>
        </p:blipFill>
        <p:spPr>
          <a:xfrm>
            <a:off x="588658" y="6205159"/>
            <a:ext cx="5680681" cy="22584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C7E3927-A2DA-49F1-8D0D-C3CA4F454CA4}"/>
              </a:ext>
            </a:extLst>
          </p:cNvPr>
          <p:cNvSpPr txBox="1"/>
          <p:nvPr/>
        </p:nvSpPr>
        <p:spPr>
          <a:xfrm>
            <a:off x="689723" y="6633403"/>
            <a:ext cx="564109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en-US" sz="12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2. Distribution of intra-group coefficient of variation of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mbrane proteins in soybean treated with plant-derived smoke. Blue and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d colors mean  untreated and treated proteins, respectively, with plant-derived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moke solution.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81803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E1B3C47E-8343-483C-ACB4-1CABFB0BB04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8225" y="1548384"/>
            <a:ext cx="6315456" cy="465734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9499262-720A-4E1A-938E-FAB655F98DF5}"/>
              </a:ext>
            </a:extLst>
          </p:cNvPr>
          <p:cNvSpPr txBox="1"/>
          <p:nvPr/>
        </p:nvSpPr>
        <p:spPr>
          <a:xfrm>
            <a:off x="268225" y="6313438"/>
            <a:ext cx="61421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en-US" sz="12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fferentially abundant </a:t>
            </a:r>
            <a:r>
              <a:rPr lang="en-US" altLang="ja-JP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r>
              <a:rPr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roteins under control</a:t>
            </a:r>
          </a:p>
          <a:p>
            <a:r>
              <a:rPr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plant-derived smoke solution treatment. Each group was performed with </a:t>
            </a:r>
          </a:p>
          <a:p>
            <a:r>
              <a:rPr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3 biological replicates. </a:t>
            </a:r>
            <a:r>
              <a:rPr kumimoji="1" lang="en-US" altLang="ja-JP" sz="12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red colors mean  untreated and treated proteins,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spectively, with plant-derived smoke solution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9372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93F0E1E1-EF4A-4998-8F41-DD198E5E3F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933" y="386206"/>
            <a:ext cx="6134133" cy="577278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C9F69C4-02F5-46AE-A5D2-F73613B71ADF}"/>
              </a:ext>
            </a:extLst>
          </p:cNvPr>
          <p:cNvSpPr txBox="1"/>
          <p:nvPr/>
        </p:nvSpPr>
        <p:spPr>
          <a:xfrm>
            <a:off x="689723" y="6633403"/>
            <a:ext cx="564109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en-US" sz="12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4. Distribution of intra-group coefficient of variation of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clear proteins in soybean treated with plant-derived smoke. Blue and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d colors mean  untreated and treated proteins, respectively, with plant-derived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moke solution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39676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43FB7F0-F66B-4101-B67F-AE2F5C4C4FAA}"/>
              </a:ext>
            </a:extLst>
          </p:cNvPr>
          <p:cNvSpPr txBox="1"/>
          <p:nvPr/>
        </p:nvSpPr>
        <p:spPr>
          <a:xfrm>
            <a:off x="1323975" y="6596903"/>
            <a:ext cx="411912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sz="1200" kern="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en-US" sz="1200" kern="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5. B</a:t>
            </a:r>
            <a:r>
              <a:rPr lang="en-US" altLang="ja-JP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lots of the entire membrane</a:t>
            </a:r>
          </a:p>
          <a:p>
            <a:pPr algn="l"/>
            <a:r>
              <a:rPr lang="en-US" altLang="ja-JP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with anti-ATPase antibody, which were used in Figure 6.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roteins (10 </a:t>
            </a:r>
            <a:r>
              <a:rPr lang="en-US" altLang="ja-JP" sz="1200" dirty="0" err="1">
                <a:effectLst/>
                <a:latin typeface="Arial" panose="020B0604020202020204" pitchFamily="34" charset="0"/>
                <a:ea typeface="WvslmxAdvTT3713a231+03"/>
                <a:cs typeface="Arial" panose="020B0604020202020204" pitchFamily="34" charset="0"/>
              </a:rPr>
              <a:t>μ</a:t>
            </a:r>
            <a:r>
              <a:rPr lang="en-US" altLang="ja-JP" sz="12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extracted from root were separated on SDS-polyacrylamide gel and transferred on to polyvinylidene difluoride membrane. The polyvinylidene difluoride membrane was cross-reacted with anti-ATPase antibody.</a:t>
            </a:r>
            <a:r>
              <a:rPr lang="en-US" altLang="ja-JP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Data show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3 biological replicates (R1, R2, and R3)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 descr="テキスト, 手紙, カレンダー&#10;&#10;自動的に生成された説明">
            <a:extLst>
              <a:ext uri="{FF2B5EF4-FFF2-40B4-BE49-F238E27FC236}">
                <a16:creationId xmlns:a16="http://schemas.microsoft.com/office/drawing/2014/main" id="{88BB373B-8B9A-4258-BA23-04F176A71B6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100"/>
          <a:stretch/>
        </p:blipFill>
        <p:spPr>
          <a:xfrm rot="16200000">
            <a:off x="1956982" y="2512267"/>
            <a:ext cx="3050306" cy="332166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E3BAF78-8A82-4D62-B107-61E3334DECEE}"/>
              </a:ext>
            </a:extLst>
          </p:cNvPr>
          <p:cNvSpPr txBox="1"/>
          <p:nvPr/>
        </p:nvSpPr>
        <p:spPr>
          <a:xfrm>
            <a:off x="1821299" y="5698254"/>
            <a:ext cx="313579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    R1   R2   R3     R1   R2   R3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         Control              Smok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DA21ECC-3699-40C7-ADB2-7638925A3D79}"/>
              </a:ext>
            </a:extLst>
          </p:cNvPr>
          <p:cNvSpPr txBox="1"/>
          <p:nvPr/>
        </p:nvSpPr>
        <p:spPr>
          <a:xfrm>
            <a:off x="1323975" y="2659247"/>
            <a:ext cx="59503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4F27620-E991-41B1-8D0A-CD773B14E4D3}"/>
              </a:ext>
            </a:extLst>
          </p:cNvPr>
          <p:cNvSpPr txBox="1"/>
          <p:nvPr/>
        </p:nvSpPr>
        <p:spPr>
          <a:xfrm>
            <a:off x="1437788" y="3131895"/>
            <a:ext cx="481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75-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769E82C-4C13-4F19-BD44-99BCD09B229A}"/>
              </a:ext>
            </a:extLst>
          </p:cNvPr>
          <p:cNvSpPr txBox="1"/>
          <p:nvPr/>
        </p:nvSpPr>
        <p:spPr>
          <a:xfrm>
            <a:off x="1437788" y="3702127"/>
            <a:ext cx="481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-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D6584A7-6E4D-423C-A808-755C3FD08AEA}"/>
              </a:ext>
            </a:extLst>
          </p:cNvPr>
          <p:cNvSpPr txBox="1"/>
          <p:nvPr/>
        </p:nvSpPr>
        <p:spPr>
          <a:xfrm>
            <a:off x="1437788" y="4209958"/>
            <a:ext cx="481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7-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D5243D5-4195-4C3C-AF6D-4B58731E8688}"/>
              </a:ext>
            </a:extLst>
          </p:cNvPr>
          <p:cNvSpPr txBox="1"/>
          <p:nvPr/>
        </p:nvSpPr>
        <p:spPr>
          <a:xfrm>
            <a:off x="1437788" y="4815374"/>
            <a:ext cx="481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63D3D10-3184-4661-88D8-40F5525A03DE}"/>
              </a:ext>
            </a:extLst>
          </p:cNvPr>
          <p:cNvSpPr txBox="1"/>
          <p:nvPr/>
        </p:nvSpPr>
        <p:spPr>
          <a:xfrm>
            <a:off x="1437788" y="5149588"/>
            <a:ext cx="481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0-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96C0B749-FAA3-4583-B72C-2C0185776D51}"/>
              </a:ext>
            </a:extLst>
          </p:cNvPr>
          <p:cNvSpPr/>
          <p:nvPr/>
        </p:nvSpPr>
        <p:spPr>
          <a:xfrm>
            <a:off x="2295525" y="3110907"/>
            <a:ext cx="2661569" cy="23236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AFEA3763-73D7-40AE-9568-C52D4E5A964D}"/>
              </a:ext>
            </a:extLst>
          </p:cNvPr>
          <p:cNvCxnSpPr/>
          <p:nvPr/>
        </p:nvCxnSpPr>
        <p:spPr>
          <a:xfrm>
            <a:off x="2302521" y="5993691"/>
            <a:ext cx="11264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9191E248-68C1-4BA8-9EE5-63DDE2F17EDD}"/>
              </a:ext>
            </a:extLst>
          </p:cNvPr>
          <p:cNvCxnSpPr/>
          <p:nvPr/>
        </p:nvCxnSpPr>
        <p:spPr>
          <a:xfrm>
            <a:off x="3712221" y="6003216"/>
            <a:ext cx="11264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63217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241</Words>
  <Application>Microsoft Office PowerPoint</Application>
  <PresentationFormat>A4 Paper (210x297 mm)</PresentationFormat>
  <Paragraphs>2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4" baseType="lpstr">
      <vt:lpstr>WvslmxAdvTT3713a231+03</vt:lpstr>
      <vt:lpstr>游ゴシック</vt:lpstr>
      <vt:lpstr>游ゴシック Light</vt:lpstr>
      <vt:lpstr>游明朝</vt:lpstr>
      <vt:lpstr>SimSun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松 節子 (futt)</dc:creator>
  <cp:lastModifiedBy>MDPI</cp:lastModifiedBy>
  <cp:revision>11</cp:revision>
  <dcterms:created xsi:type="dcterms:W3CDTF">2021-09-25T01:11:39Z</dcterms:created>
  <dcterms:modified xsi:type="dcterms:W3CDTF">2021-10-02T09:54:17Z</dcterms:modified>
</cp:coreProperties>
</file>